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2" r:id="rId3"/>
    <p:sldId id="263" r:id="rId4"/>
    <p:sldId id="25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3" autoAdjust="0"/>
    <p:restoredTop sz="94689"/>
  </p:normalViewPr>
  <p:slideViewPr>
    <p:cSldViewPr snapToGrid="0" showGuides="1">
      <p:cViewPr varScale="1">
        <p:scale>
          <a:sx n="57" d="100"/>
          <a:sy n="57" d="100"/>
        </p:scale>
        <p:origin x="948" y="3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84B6E7-3E4D-97ED-1227-F16834451E4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BC67229-E85A-4EB2-C167-2F4562371DB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878025-3172-8914-8815-574559212F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364DD-2A71-4AD3-9398-4522EF447F5A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86E353-0EB2-6AE7-FD4D-07DB79BA87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DC8CB4-9C82-527A-860B-6ADA8F6D25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52DB1-B949-4E93-8DDF-14AF5092E1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6320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EF4CD1-4FA1-17D7-C608-9C13C3B928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CEFF402-D1DE-9CC6-E399-67A86E34DD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CB12B6-9F38-85CA-58AE-F77B780070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364DD-2A71-4AD3-9398-4522EF447F5A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3E5722-2457-365E-17B3-816AB171FC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7069D8-3BF2-AEB0-FE83-4732AE6A8A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52DB1-B949-4E93-8DDF-14AF5092E1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40463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7E86A41-630F-F24A-7D82-82104D25E54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A8D60B4-79CC-EAAB-42A9-6DA5330DF72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5B24D4-EAE2-39E8-6F0A-B1B1AE4137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364DD-2A71-4AD3-9398-4522EF447F5A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417FD9-B43B-C793-8198-F8BB842586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6CB7AB-8A63-133B-0C57-E6BD1B8B4B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52DB1-B949-4E93-8DDF-14AF5092E1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81935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A9895F-FF67-45C6-1B6B-95BA3E6159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15D3A1-9606-DFC7-C2F4-C02C868E108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7ED3C3-D772-6C6B-49A5-CA478E9994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364DD-2A71-4AD3-9398-4522EF447F5A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7FF3F8-E717-AECD-36A2-28B241AF5E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9F70CA-F914-A34C-2E7D-23E7C0D784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52DB1-B949-4E93-8DDF-14AF5092E1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69280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09A9A4-F190-AF3F-78C3-68DF3BC78F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53542D9-14FA-ACE0-ECDF-2EB0FBDC80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DC3BCD-DEC0-2DF5-529B-6335F1B452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364DD-2A71-4AD3-9398-4522EF447F5A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FF0025-93EB-52E3-C445-EADAC929F3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DAC9C0-A372-4E19-13E8-136D920A53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52DB1-B949-4E93-8DDF-14AF5092E1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09329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0564DD-F2A4-2A23-DD56-9892E248E4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3F95AE-28FE-F832-CEE4-9C32B30C280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0740460-00C2-216C-EDEC-FD0AC1AD42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E0D3F2-E588-56AC-F6C3-9B0C610F33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364DD-2A71-4AD3-9398-4522EF447F5A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5A16731-F7FF-940E-0661-14C31568C0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674C4E-449A-3FE6-516F-DD5DD51291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52DB1-B949-4E93-8DDF-14AF5092E1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09101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C610A7-63E4-2814-B9C0-0B989646A1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5694EC-CA4B-8D4D-D7CF-C540B096B4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786F37B-6156-F780-96D2-3705C0A3DC4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2D60D49-B7EF-9819-D9BF-B9EB8713A87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EB6CB6E-46E6-21F6-61D3-E413F2C5F8F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56027B8-41AD-63D5-47A5-483AE1AB77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364DD-2A71-4AD3-9398-4522EF447F5A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D843C7A-D9C4-923E-0D1D-3735A79310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077B980-63FD-A57A-FDB2-B3032D4EDC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52DB1-B949-4E93-8DDF-14AF5092E1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4704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C72D0E-3B1D-1980-F067-5ECC870DC9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FC9FB97-FA60-A177-D3DA-DD53F892A2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364DD-2A71-4AD3-9398-4522EF447F5A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FA46ACE-6668-5370-4AB8-D987B77F9A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3428800-A923-47E0-B83E-396B1BA631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52DB1-B949-4E93-8DDF-14AF5092E1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08501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55F23D8-156E-FD32-374F-34F3F0533E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364DD-2A71-4AD3-9398-4522EF447F5A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B98B27F-C3D7-76C5-88AE-E7CA02F0C6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55453D4-F901-5748-5F0F-7062EFA5AE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52DB1-B949-4E93-8DDF-14AF5092E1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25906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903B58-ABA8-5330-7126-EB23BDB410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A84A743-0E3C-F663-5DAE-54EBA60C7B5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F893FD8-04AE-5D42-BAB2-103528C20C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001E790-782C-F783-1442-96A7106886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364DD-2A71-4AD3-9398-4522EF447F5A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C4944C6-A97A-737A-B4AC-1A0C7E7B9E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2F015A-EF6D-1EE5-9427-4EAB368993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52DB1-B949-4E93-8DDF-14AF5092E1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9915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1B57D3-7D88-03C9-E12E-5B0DC90D77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07FC340-AD91-88D0-DF9A-EFA7171B825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66AB276-289E-45D4-C79D-2A5AE448BDF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5EFDAC-3F50-C933-6254-28F9CB6F50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364DD-2A71-4AD3-9398-4522EF447F5A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EC8F3F5-4761-03F7-B379-C8514489A7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19A134-624A-421A-3997-BEA6CB90E5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52DB1-B949-4E93-8DDF-14AF5092E1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61532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C6A3B07-FF24-21A7-D614-2308C9A71C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13B865-939C-8577-D8B8-1C16C0C145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E0B9C4-86FB-3940-1E9A-2D821DF0E45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D3364DD-2A71-4AD3-9398-4522EF447F5A}" type="datetimeFigureOut">
              <a:rPr lang="en-GB" smtClean="0"/>
              <a:t>16/07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D3DED9-2DE9-8649-7A1A-8AAE0FB4EAF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F88E19-26FA-24B5-5BFE-9361398E890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8752DB1-B949-4E93-8DDF-14AF5092E1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19096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E69CED8-14A9-3A8C-0AD4-D65004B7513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BFA7E2-E0F0-58E7-3F8A-A4DB8A555D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65101"/>
            <a:ext cx="10515600" cy="863600"/>
          </a:xfrm>
        </p:spPr>
        <p:txBody>
          <a:bodyPr>
            <a:normAutofit/>
          </a:bodyPr>
          <a:lstStyle/>
          <a:p>
            <a:r>
              <a:rPr lang="en-US" sz="1800" b="1" dirty="0"/>
              <a:t>Figure 6A: Full length blot images: Females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CDB2B87-92CB-6994-D39C-778DE4736A88}"/>
              </a:ext>
            </a:extLst>
          </p:cNvPr>
          <p:cNvSpPr txBox="1"/>
          <p:nvPr/>
        </p:nvSpPr>
        <p:spPr>
          <a:xfrm>
            <a:off x="2635194" y="1021622"/>
            <a:ext cx="9909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Vinculin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8204463B-028B-4186-5CA9-2D17F39399C1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8216" r="2116" b="28095"/>
          <a:stretch/>
        </p:blipFill>
        <p:spPr>
          <a:xfrm flipH="1">
            <a:off x="892663" y="1390954"/>
            <a:ext cx="5467015" cy="3508454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407ADB68-AAF7-FDD9-F181-664F671F25EF}"/>
              </a:ext>
            </a:extLst>
          </p:cNvPr>
          <p:cNvSpPr/>
          <p:nvPr/>
        </p:nvSpPr>
        <p:spPr>
          <a:xfrm>
            <a:off x="3953022" y="1800665"/>
            <a:ext cx="450166" cy="6049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CA48DF88-9DC6-4320-7A61-B50FCBA7747B}"/>
              </a:ext>
            </a:extLst>
          </p:cNvPr>
          <p:cNvSpPr/>
          <p:nvPr/>
        </p:nvSpPr>
        <p:spPr>
          <a:xfrm>
            <a:off x="4529371" y="1800665"/>
            <a:ext cx="450166" cy="6049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F63A1E81-7233-17E5-3884-C3DF58A1E080}"/>
              </a:ext>
            </a:extLst>
          </p:cNvPr>
          <p:cNvSpPr/>
          <p:nvPr/>
        </p:nvSpPr>
        <p:spPr>
          <a:xfrm>
            <a:off x="5105720" y="1800665"/>
            <a:ext cx="450166" cy="6049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CDA463C6-243E-B36F-8C79-8EE339999758}"/>
              </a:ext>
            </a:extLst>
          </p:cNvPr>
          <p:cNvSpPr/>
          <p:nvPr/>
        </p:nvSpPr>
        <p:spPr>
          <a:xfrm>
            <a:off x="5682069" y="1800665"/>
            <a:ext cx="450166" cy="6049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2FACF8B-5E31-CD1F-07F8-459281444903}"/>
              </a:ext>
            </a:extLst>
          </p:cNvPr>
          <p:cNvSpPr txBox="1"/>
          <p:nvPr/>
        </p:nvSpPr>
        <p:spPr>
          <a:xfrm>
            <a:off x="3896431" y="1511610"/>
            <a:ext cx="709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WT C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E3ACDEB-A92E-ACE6-9DDC-EB6600670D7E}"/>
              </a:ext>
            </a:extLst>
          </p:cNvPr>
          <p:cNvSpPr txBox="1"/>
          <p:nvPr/>
        </p:nvSpPr>
        <p:spPr>
          <a:xfrm>
            <a:off x="4396580" y="1525348"/>
            <a:ext cx="709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WT HF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414B004-8CED-58D1-7CF2-689BD492C831}"/>
              </a:ext>
            </a:extLst>
          </p:cNvPr>
          <p:cNvSpPr txBox="1"/>
          <p:nvPr/>
        </p:nvSpPr>
        <p:spPr>
          <a:xfrm>
            <a:off x="4896623" y="1525347"/>
            <a:ext cx="8683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Stk26 </a:t>
            </a:r>
            <a:r>
              <a:rPr lang="en-US" sz="1000" baseline="30000" dirty="0"/>
              <a:t>-/-</a:t>
            </a:r>
            <a:r>
              <a:rPr lang="en-US" sz="1000" dirty="0"/>
              <a:t> C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0EBF8DF-12BE-42D2-5FEC-28B688C227F6}"/>
              </a:ext>
            </a:extLst>
          </p:cNvPr>
          <p:cNvSpPr txBox="1"/>
          <p:nvPr/>
        </p:nvSpPr>
        <p:spPr>
          <a:xfrm>
            <a:off x="5574338" y="1511609"/>
            <a:ext cx="11149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Stk26 </a:t>
            </a:r>
            <a:r>
              <a:rPr lang="en-US" sz="1000" baseline="30000" dirty="0"/>
              <a:t>-/-</a:t>
            </a:r>
            <a:r>
              <a:rPr lang="en-US" sz="1000" dirty="0"/>
              <a:t> HFD</a:t>
            </a:r>
          </a:p>
        </p:txBody>
      </p:sp>
    </p:spTree>
    <p:extLst>
      <p:ext uri="{BB962C8B-B14F-4D97-AF65-F5344CB8AC3E}">
        <p14:creationId xmlns:p14="http://schemas.microsoft.com/office/powerpoint/2010/main" val="17612666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DC1A224-78B7-766A-F89B-8A28DC6F43A9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9804" t="6183" r="3248" b="15537"/>
          <a:stretch/>
        </p:blipFill>
        <p:spPr>
          <a:xfrm flipH="1">
            <a:off x="3430144" y="1232579"/>
            <a:ext cx="5995209" cy="394742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209A98C-089E-35AE-A424-C878D051BEE5}"/>
              </a:ext>
            </a:extLst>
          </p:cNvPr>
          <p:cNvSpPr txBox="1"/>
          <p:nvPr/>
        </p:nvSpPr>
        <p:spPr>
          <a:xfrm>
            <a:off x="6197282" y="863247"/>
            <a:ext cx="9215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LC3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AE5E0D06-AE93-E707-B6AF-9193B68978A4}"/>
              </a:ext>
            </a:extLst>
          </p:cNvPr>
          <p:cNvSpPr/>
          <p:nvPr/>
        </p:nvSpPr>
        <p:spPr>
          <a:xfrm>
            <a:off x="6977576" y="4110111"/>
            <a:ext cx="450166" cy="6049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264547AD-5161-F8A0-8D9C-E9E1E805080A}"/>
              </a:ext>
            </a:extLst>
          </p:cNvPr>
          <p:cNvSpPr/>
          <p:nvPr/>
        </p:nvSpPr>
        <p:spPr>
          <a:xfrm>
            <a:off x="7563730" y="4110111"/>
            <a:ext cx="450166" cy="6049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9D6BF9D9-7EE3-CEE9-53F9-A7C71EA28863}"/>
              </a:ext>
            </a:extLst>
          </p:cNvPr>
          <p:cNvSpPr/>
          <p:nvPr/>
        </p:nvSpPr>
        <p:spPr>
          <a:xfrm>
            <a:off x="8102992" y="4110111"/>
            <a:ext cx="450166" cy="6049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D481DCA1-B7E7-9C48-4FF4-F198C0263712}"/>
              </a:ext>
            </a:extLst>
          </p:cNvPr>
          <p:cNvSpPr/>
          <p:nvPr/>
        </p:nvSpPr>
        <p:spPr>
          <a:xfrm>
            <a:off x="8642254" y="4110111"/>
            <a:ext cx="450166" cy="6049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CD032A6-41BA-AD0A-A357-08AED11979AB}"/>
              </a:ext>
            </a:extLst>
          </p:cNvPr>
          <p:cNvSpPr txBox="1"/>
          <p:nvPr/>
        </p:nvSpPr>
        <p:spPr>
          <a:xfrm>
            <a:off x="6876227" y="3645132"/>
            <a:ext cx="709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WT C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9CDFC33-6896-5FC3-6A36-E56AA3CEE2D7}"/>
              </a:ext>
            </a:extLst>
          </p:cNvPr>
          <p:cNvSpPr txBox="1"/>
          <p:nvPr/>
        </p:nvSpPr>
        <p:spPr>
          <a:xfrm>
            <a:off x="8578951" y="3645132"/>
            <a:ext cx="8928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Stk26 </a:t>
            </a:r>
            <a:r>
              <a:rPr lang="en-US" sz="1000" b="1" baseline="30000" dirty="0"/>
              <a:t>-/-</a:t>
            </a:r>
            <a:r>
              <a:rPr lang="en-US" sz="1000" b="1" dirty="0"/>
              <a:t> HF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896D9F0-7D87-3543-1DE7-9D022F614309}"/>
              </a:ext>
            </a:extLst>
          </p:cNvPr>
          <p:cNvSpPr txBox="1"/>
          <p:nvPr/>
        </p:nvSpPr>
        <p:spPr>
          <a:xfrm>
            <a:off x="7996150" y="3645132"/>
            <a:ext cx="6638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Stk26 </a:t>
            </a:r>
            <a:r>
              <a:rPr lang="en-US" sz="1000" b="1" baseline="30000" dirty="0"/>
              <a:t>-/-</a:t>
            </a:r>
            <a:r>
              <a:rPr lang="en-US" sz="1000" b="1" dirty="0"/>
              <a:t> C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1F212D4-2625-03C0-0573-55B1540A547E}"/>
              </a:ext>
            </a:extLst>
          </p:cNvPr>
          <p:cNvSpPr txBox="1"/>
          <p:nvPr/>
        </p:nvSpPr>
        <p:spPr>
          <a:xfrm>
            <a:off x="7394388" y="3645132"/>
            <a:ext cx="709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WT HFD</a:t>
            </a:r>
          </a:p>
        </p:txBody>
      </p:sp>
      <p:sp>
        <p:nvSpPr>
          <p:cNvPr id="12" name="Title 1">
            <a:extLst>
              <a:ext uri="{FF2B5EF4-FFF2-40B4-BE49-F238E27FC236}">
                <a16:creationId xmlns:a16="http://schemas.microsoft.com/office/drawing/2014/main" id="{36D98BC7-C0F8-2B6C-80AF-F87EF0FBAE9D}"/>
              </a:ext>
            </a:extLst>
          </p:cNvPr>
          <p:cNvSpPr txBox="1">
            <a:spLocks/>
          </p:cNvSpPr>
          <p:nvPr/>
        </p:nvSpPr>
        <p:spPr>
          <a:xfrm>
            <a:off x="838200" y="165101"/>
            <a:ext cx="10515600" cy="863600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b="1"/>
              <a:t>Figure 6A: Full length blot images: Females </a:t>
            </a:r>
            <a:endParaRPr lang="en-US" sz="1800" b="1" dirty="0"/>
          </a:p>
        </p:txBody>
      </p:sp>
    </p:spTree>
    <p:extLst>
      <p:ext uri="{BB962C8B-B14F-4D97-AF65-F5344CB8AC3E}">
        <p14:creationId xmlns:p14="http://schemas.microsoft.com/office/powerpoint/2010/main" val="20029810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A37F3AD-36CB-13B0-E1A3-1B10E2376029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451" t="10369" r="18505" b="13402"/>
          <a:stretch/>
        </p:blipFill>
        <p:spPr>
          <a:xfrm flipH="1">
            <a:off x="2194561" y="1585769"/>
            <a:ext cx="5765995" cy="413109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99CFAD6-C698-B125-8430-6C228121B1C6}"/>
              </a:ext>
            </a:extLst>
          </p:cNvPr>
          <p:cNvSpPr txBox="1"/>
          <p:nvPr/>
        </p:nvSpPr>
        <p:spPr>
          <a:xfrm>
            <a:off x="4960518" y="1141139"/>
            <a:ext cx="10144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LC3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0E054213-D153-394E-4026-AB4037FEED5A}"/>
              </a:ext>
            </a:extLst>
          </p:cNvPr>
          <p:cNvSpPr/>
          <p:nvPr/>
        </p:nvSpPr>
        <p:spPr>
          <a:xfrm>
            <a:off x="5563935" y="4567311"/>
            <a:ext cx="450166" cy="6049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52A3146B-352D-EFAC-1396-30ABE9D5C3FF}"/>
              </a:ext>
            </a:extLst>
          </p:cNvPr>
          <p:cNvSpPr/>
          <p:nvPr/>
        </p:nvSpPr>
        <p:spPr>
          <a:xfrm>
            <a:off x="6150089" y="4567311"/>
            <a:ext cx="450166" cy="6049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4C5869BB-3CC6-797E-7E1A-026E7FA38959}"/>
              </a:ext>
            </a:extLst>
          </p:cNvPr>
          <p:cNvSpPr/>
          <p:nvPr/>
        </p:nvSpPr>
        <p:spPr>
          <a:xfrm>
            <a:off x="6689351" y="4567311"/>
            <a:ext cx="450166" cy="6049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BA8F5026-28F9-DD58-E66B-904D423BE7E3}"/>
              </a:ext>
            </a:extLst>
          </p:cNvPr>
          <p:cNvSpPr/>
          <p:nvPr/>
        </p:nvSpPr>
        <p:spPr>
          <a:xfrm>
            <a:off x="7228613" y="4567311"/>
            <a:ext cx="450166" cy="6049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8375BB8-B153-2F2D-0C2A-283EA91E95E3}"/>
              </a:ext>
            </a:extLst>
          </p:cNvPr>
          <p:cNvSpPr txBox="1"/>
          <p:nvPr/>
        </p:nvSpPr>
        <p:spPr>
          <a:xfrm>
            <a:off x="5502650" y="4167201"/>
            <a:ext cx="709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WT CD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0F17259-DC3A-0EFE-5EE3-6EF8ED9F14C0}"/>
              </a:ext>
            </a:extLst>
          </p:cNvPr>
          <p:cNvSpPr txBox="1"/>
          <p:nvPr/>
        </p:nvSpPr>
        <p:spPr>
          <a:xfrm>
            <a:off x="7205374" y="4167201"/>
            <a:ext cx="8928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Stk26 </a:t>
            </a:r>
            <a:r>
              <a:rPr lang="en-US" sz="1000" b="1" baseline="30000" dirty="0"/>
              <a:t>-/-</a:t>
            </a:r>
            <a:r>
              <a:rPr lang="en-US" sz="1000" b="1" dirty="0"/>
              <a:t> HFD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92A4796-C5C5-7EB5-0381-E5EF80A46C76}"/>
              </a:ext>
            </a:extLst>
          </p:cNvPr>
          <p:cNvSpPr txBox="1"/>
          <p:nvPr/>
        </p:nvSpPr>
        <p:spPr>
          <a:xfrm>
            <a:off x="6622573" y="4167201"/>
            <a:ext cx="6638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Stk26 </a:t>
            </a:r>
            <a:r>
              <a:rPr lang="en-US" sz="1000" b="1" baseline="30000" dirty="0"/>
              <a:t>-/-</a:t>
            </a:r>
            <a:r>
              <a:rPr lang="en-US" sz="1000" b="1" dirty="0"/>
              <a:t> CD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9A257BD-E254-83F0-17B4-D9157994AE68}"/>
              </a:ext>
            </a:extLst>
          </p:cNvPr>
          <p:cNvSpPr txBox="1"/>
          <p:nvPr/>
        </p:nvSpPr>
        <p:spPr>
          <a:xfrm>
            <a:off x="6020811" y="4167201"/>
            <a:ext cx="709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WT HFD</a:t>
            </a:r>
          </a:p>
        </p:txBody>
      </p:sp>
      <p:sp>
        <p:nvSpPr>
          <p:cNvPr id="4" name="Title 1">
            <a:extLst>
              <a:ext uri="{FF2B5EF4-FFF2-40B4-BE49-F238E27FC236}">
                <a16:creationId xmlns:a16="http://schemas.microsoft.com/office/drawing/2014/main" id="{575402D8-11EB-46B3-ED99-74D59700EFF0}"/>
              </a:ext>
            </a:extLst>
          </p:cNvPr>
          <p:cNvSpPr txBox="1">
            <a:spLocks/>
          </p:cNvSpPr>
          <p:nvPr/>
        </p:nvSpPr>
        <p:spPr>
          <a:xfrm>
            <a:off x="838200" y="165101"/>
            <a:ext cx="10515600" cy="863600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b="1" dirty="0"/>
              <a:t>Figure 6A: Full length blot images: Males </a:t>
            </a:r>
          </a:p>
        </p:txBody>
      </p:sp>
    </p:spTree>
    <p:extLst>
      <p:ext uri="{BB962C8B-B14F-4D97-AF65-F5344CB8AC3E}">
        <p14:creationId xmlns:p14="http://schemas.microsoft.com/office/powerpoint/2010/main" val="29181780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6BD2DB0B-238B-6992-B42D-B718C9A0C9AC}"/>
              </a:ext>
            </a:extLst>
          </p:cNvPr>
          <p:cNvSpPr txBox="1"/>
          <p:nvPr/>
        </p:nvSpPr>
        <p:spPr>
          <a:xfrm>
            <a:off x="5365399" y="1668922"/>
            <a:ext cx="9909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Vinculin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A4ACEBB9-9915-1B8C-CEAE-F3A0635CC88D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8742" t="14066" r="11859" b="2612"/>
          <a:stretch/>
        </p:blipFill>
        <p:spPr>
          <a:xfrm flipH="1">
            <a:off x="3002657" y="2136948"/>
            <a:ext cx="5626496" cy="3809799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AB852E12-20C8-4F14-5A08-91078048DA85}"/>
              </a:ext>
            </a:extLst>
          </p:cNvPr>
          <p:cNvSpPr/>
          <p:nvPr/>
        </p:nvSpPr>
        <p:spPr>
          <a:xfrm>
            <a:off x="6306078" y="2233481"/>
            <a:ext cx="450166" cy="6049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9071F3DA-FF97-467C-945B-DE533ED8FFBB}"/>
              </a:ext>
            </a:extLst>
          </p:cNvPr>
          <p:cNvSpPr/>
          <p:nvPr/>
        </p:nvSpPr>
        <p:spPr>
          <a:xfrm>
            <a:off x="6912907" y="2233481"/>
            <a:ext cx="450166" cy="6049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66C2A069-9659-F727-B2FD-448940AF1EA8}"/>
              </a:ext>
            </a:extLst>
          </p:cNvPr>
          <p:cNvSpPr/>
          <p:nvPr/>
        </p:nvSpPr>
        <p:spPr>
          <a:xfrm>
            <a:off x="7525832" y="2233481"/>
            <a:ext cx="450166" cy="6049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1D28CEAE-16E3-5D65-5E56-D9ED9F90400C}"/>
              </a:ext>
            </a:extLst>
          </p:cNvPr>
          <p:cNvSpPr/>
          <p:nvPr/>
        </p:nvSpPr>
        <p:spPr>
          <a:xfrm>
            <a:off x="8114373" y="2233481"/>
            <a:ext cx="514780" cy="6049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CA1FE66-8C43-7FE3-1D2E-AFB3A78E1835}"/>
              </a:ext>
            </a:extLst>
          </p:cNvPr>
          <p:cNvSpPr txBox="1"/>
          <p:nvPr/>
        </p:nvSpPr>
        <p:spPr>
          <a:xfrm>
            <a:off x="6206815" y="1957622"/>
            <a:ext cx="709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WT C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7D3941F-A773-8924-D4F0-CEE0241C35B3}"/>
              </a:ext>
            </a:extLst>
          </p:cNvPr>
          <p:cNvSpPr txBox="1"/>
          <p:nvPr/>
        </p:nvSpPr>
        <p:spPr>
          <a:xfrm>
            <a:off x="6824994" y="1954095"/>
            <a:ext cx="709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WT HF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52480E9-3E84-BB37-F558-96B752CC61BC}"/>
              </a:ext>
            </a:extLst>
          </p:cNvPr>
          <p:cNvSpPr txBox="1"/>
          <p:nvPr/>
        </p:nvSpPr>
        <p:spPr>
          <a:xfrm>
            <a:off x="7325143" y="1959657"/>
            <a:ext cx="8683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Stk26 </a:t>
            </a:r>
            <a:r>
              <a:rPr lang="en-US" sz="1000" baseline="30000" dirty="0"/>
              <a:t>-/-</a:t>
            </a:r>
            <a:r>
              <a:rPr lang="en-US" sz="1000" dirty="0"/>
              <a:t> C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D4B0630-8297-78D2-A710-FD7D431D2D10}"/>
              </a:ext>
            </a:extLst>
          </p:cNvPr>
          <p:cNvSpPr txBox="1"/>
          <p:nvPr/>
        </p:nvSpPr>
        <p:spPr>
          <a:xfrm>
            <a:off x="8014331" y="1957621"/>
            <a:ext cx="11149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Stk26 </a:t>
            </a:r>
            <a:r>
              <a:rPr lang="en-US" sz="1000" baseline="30000" dirty="0"/>
              <a:t>-/-</a:t>
            </a:r>
            <a:r>
              <a:rPr lang="en-US" sz="1000" dirty="0"/>
              <a:t> HFD</a:t>
            </a:r>
          </a:p>
        </p:txBody>
      </p:sp>
      <p:sp>
        <p:nvSpPr>
          <p:cNvPr id="13" name="Title 1">
            <a:extLst>
              <a:ext uri="{FF2B5EF4-FFF2-40B4-BE49-F238E27FC236}">
                <a16:creationId xmlns:a16="http://schemas.microsoft.com/office/drawing/2014/main" id="{B2CC6AFE-0C76-1DBB-4651-A8849322E93F}"/>
              </a:ext>
            </a:extLst>
          </p:cNvPr>
          <p:cNvSpPr txBox="1">
            <a:spLocks/>
          </p:cNvSpPr>
          <p:nvPr/>
        </p:nvSpPr>
        <p:spPr>
          <a:xfrm>
            <a:off x="838200" y="165101"/>
            <a:ext cx="10515600" cy="863600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b="1" dirty="0"/>
              <a:t>Figure 6A: Full length blot images: Males </a:t>
            </a:r>
          </a:p>
        </p:txBody>
      </p:sp>
    </p:spTree>
    <p:extLst>
      <p:ext uri="{BB962C8B-B14F-4D97-AF65-F5344CB8AC3E}">
        <p14:creationId xmlns:p14="http://schemas.microsoft.com/office/powerpoint/2010/main" val="2596996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80</Words>
  <Application>Microsoft Office PowerPoint</Application>
  <PresentationFormat>Widescreen</PresentationFormat>
  <Paragraphs>2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ptos</vt:lpstr>
      <vt:lpstr>Aptos Display</vt:lpstr>
      <vt:lpstr>Arial</vt:lpstr>
      <vt:lpstr>Office Theme</vt:lpstr>
      <vt:lpstr>Figure 6A: Full length blot images: Females </vt:lpstr>
      <vt:lpstr>PowerPoint Presentation</vt:lpstr>
      <vt:lpstr>PowerPoint Presentation</vt:lpstr>
      <vt:lpstr>PowerPoint Presentation</vt:lpstr>
    </vt:vector>
  </TitlesOfParts>
  <Company>University of Birmingha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ennifer Niven (Inflammation and Ageing)</dc:creator>
  <cp:lastModifiedBy>Jennifer Niven (Inflammation and Ageing)</cp:lastModifiedBy>
  <cp:revision>5</cp:revision>
  <dcterms:created xsi:type="dcterms:W3CDTF">2025-06-23T20:26:17Z</dcterms:created>
  <dcterms:modified xsi:type="dcterms:W3CDTF">2025-07-16T19:06:13Z</dcterms:modified>
</cp:coreProperties>
</file>